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TextBox 12"/>
          <p:cNvSpPr txBox="1"/>
          <p:nvPr/>
        </p:nvSpPr>
        <p:spPr>
          <a:xfrm>
            <a:off x="239573" y="2005375"/>
            <a:ext cx="441822" cy="246197"/>
          </a:xfrm>
          <a:prstGeom prst="rect">
            <a:avLst/>
          </a:prstGeom>
          <a:noFill/>
        </p:spPr>
        <p:txBody>
          <a:bodyPr wrap="square" lIns="91417" tIns="45708" rIns="91417" bIns="45708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39573" y="2220470"/>
            <a:ext cx="128482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Genes up-regulated in the three HIF-1 negative regulators(104)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636443" y="2274390"/>
            <a:ext cx="13716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Genes positively regulated by HIF-1 under hypoxia (64)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12"/>
          <p:cNvSpPr txBox="1"/>
          <p:nvPr/>
        </p:nvSpPr>
        <p:spPr>
          <a:xfrm>
            <a:off x="239573" y="3173991"/>
            <a:ext cx="441822" cy="246197"/>
          </a:xfrm>
          <a:prstGeom prst="rect">
            <a:avLst/>
          </a:prstGeom>
          <a:noFill/>
        </p:spPr>
        <p:txBody>
          <a:bodyPr wrap="square" lIns="91417" tIns="45708" rIns="91417" bIns="45708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600215" y="3566067"/>
            <a:ext cx="13716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Genes positively regulated by HIF-1 under hypoxia (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60)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39573" y="3412179"/>
            <a:ext cx="128482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Genes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down-regulated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in the three HIF-1 negative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regulators(95)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8124" y="2220470"/>
            <a:ext cx="1104900" cy="723900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1541522" y="2428278"/>
            <a:ext cx="881183" cy="262847"/>
            <a:chOff x="1307420" y="713125"/>
            <a:chExt cx="881183" cy="262847"/>
          </a:xfrm>
        </p:grpSpPr>
        <p:sp>
          <p:nvSpPr>
            <p:cNvPr id="62" name="TextBox 61"/>
            <p:cNvSpPr txBox="1"/>
            <p:nvPr/>
          </p:nvSpPr>
          <p:spPr>
            <a:xfrm>
              <a:off x="1620330" y="715484"/>
              <a:ext cx="414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23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307420" y="729751"/>
              <a:ext cx="419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81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855926" y="713125"/>
              <a:ext cx="3326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41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4348" y="3412179"/>
            <a:ext cx="1171575" cy="742950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1509543" y="3652230"/>
            <a:ext cx="881183" cy="262847"/>
            <a:chOff x="1313046" y="1996080"/>
            <a:chExt cx="881183" cy="262847"/>
          </a:xfrm>
        </p:grpSpPr>
        <p:sp>
          <p:nvSpPr>
            <p:cNvPr id="24" name="TextBox 23"/>
            <p:cNvSpPr txBox="1"/>
            <p:nvPr/>
          </p:nvSpPr>
          <p:spPr>
            <a:xfrm>
              <a:off x="1684147" y="1998439"/>
              <a:ext cx="414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313046" y="2012706"/>
              <a:ext cx="419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92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861552" y="1996080"/>
              <a:ext cx="3326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57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8" name="Rectangle 17"/>
          <p:cNvSpPr/>
          <p:nvPr/>
        </p:nvSpPr>
        <p:spPr>
          <a:xfrm>
            <a:off x="0" y="0"/>
            <a:ext cx="6858000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1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verlaps between genes regulated in the HIF-1 negative regulator mutants and genes regulated by HIF-1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under 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hypoxia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 Genes commonly up-regulated in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vhl-1(ok161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hy-1(ok1402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gl-9(sa307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verlapped with genes positively regulated by HIF-1 under hypoxia (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value &lt; 2.20E-16, by Fisher’s exact, this overlap is significant). (B) Genes commonly down-regulated in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vhl-1(ok161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hy-1(ok1402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gl-9(sa307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verlapped with genes negatively regulated by HIF-1 under hypoxia (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value = 0.004, by Fisher’s exact, this overlap is not significan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6498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0</TotalTime>
  <Words>142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SimSun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cBook</dc:creator>
  <cp:lastModifiedBy>Dingxia</cp:lastModifiedBy>
  <cp:revision>136</cp:revision>
  <cp:lastPrinted>2024-01-26T05:22:48Z</cp:lastPrinted>
  <dcterms:created xsi:type="dcterms:W3CDTF">2006-08-16T00:00:00Z</dcterms:created>
  <dcterms:modified xsi:type="dcterms:W3CDTF">2024-01-31T11:59:45Z</dcterms:modified>
</cp:coreProperties>
</file>